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3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elenamurphy\Desktop\Assay%20-%20proteasome%20activators%20lymphoma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357638811699235"/>
          <c:y val="2.9412641931836566E-2"/>
          <c:w val="0.73127758995753578"/>
          <c:h val="0.84265079191898962"/>
        </c:manualLayout>
      </c:layout>
      <c:barChart>
        <c:barDir val="col"/>
        <c:grouping val="clustered"/>
        <c:varyColors val="0"/>
        <c:ser>
          <c:idx val="0"/>
          <c:order val="0"/>
          <c:tx>
            <c:v>EL-4</c:v>
          </c:tx>
          <c:spPr>
            <a:solidFill>
              <a:srgbClr val="0033E8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L.4!$J$83:$J$97</c:f>
              <c:strCache>
                <c:ptCount val="15"/>
                <c:pt idx="0">
                  <c:v>Control</c:v>
                </c:pt>
                <c:pt idx="1">
                  <c:v>ACY-1215</c:v>
                </c:pt>
                <c:pt idx="2">
                  <c:v>Tubastatin A</c:v>
                </c:pt>
                <c:pt idx="3">
                  <c:v>DC661</c:v>
                </c:pt>
                <c:pt idx="4">
                  <c:v>Sclareol</c:v>
                </c:pt>
                <c:pt idx="5">
                  <c:v>Riluzole</c:v>
                </c:pt>
                <c:pt idx="6">
                  <c:v>Rapamycin</c:v>
                </c:pt>
                <c:pt idx="7">
                  <c:v>Dipyridamole</c:v>
                </c:pt>
                <c:pt idx="8">
                  <c:v>HCQ</c:v>
                </c:pt>
                <c:pt idx="9">
                  <c:v>DMNQ</c:v>
                </c:pt>
                <c:pt idx="10">
                  <c:v>Betulinic acid</c:v>
                </c:pt>
                <c:pt idx="11">
                  <c:v>Abiraterone</c:v>
                </c:pt>
                <c:pt idx="12">
                  <c:v>Rolipram</c:v>
                </c:pt>
                <c:pt idx="13">
                  <c:v>1,10-phen</c:v>
                </c:pt>
                <c:pt idx="14">
                  <c:v>Salinomycin</c:v>
                </c:pt>
              </c:strCache>
            </c:strRef>
          </c:cat>
          <c:val>
            <c:numRef>
              <c:f>EL.4!$K$83:$K$97</c:f>
              <c:numCache>
                <c:formatCode>General</c:formatCode>
                <c:ptCount val="15"/>
                <c:pt idx="0">
                  <c:v>100</c:v>
                </c:pt>
                <c:pt idx="1">
                  <c:v>148.47654600988321</c:v>
                </c:pt>
                <c:pt idx="2">
                  <c:v>125.34599498390048</c:v>
                </c:pt>
                <c:pt idx="3">
                  <c:v>97.667844815455553</c:v>
                </c:pt>
                <c:pt idx="4">
                  <c:v>115.94908576205809</c:v>
                </c:pt>
                <c:pt idx="5">
                  <c:v>105.60317355207722</c:v>
                </c:pt>
                <c:pt idx="6">
                  <c:v>117.25277499565436</c:v>
                </c:pt>
                <c:pt idx="7">
                  <c:v>129.79095446606686</c:v>
                </c:pt>
                <c:pt idx="8">
                  <c:v>116.41510292936903</c:v>
                </c:pt>
                <c:pt idx="9">
                  <c:v>111.27422171822103</c:v>
                </c:pt>
                <c:pt idx="10">
                  <c:v>107.40867967320857</c:v>
                </c:pt>
                <c:pt idx="11">
                  <c:v>100.33026793917772</c:v>
                </c:pt>
                <c:pt idx="12">
                  <c:v>97.444562167352316</c:v>
                </c:pt>
                <c:pt idx="13">
                  <c:v>95.682926223605463</c:v>
                </c:pt>
                <c:pt idx="14">
                  <c:v>94.562374287109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BD-AF43-9CC7-2DD08CD0F0C5}"/>
            </c:ext>
          </c:extLst>
        </c:ser>
        <c:ser>
          <c:idx val="1"/>
          <c:order val="1"/>
          <c:tx>
            <c:v>E.G7-OVA</c:v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L.4!$J$83:$J$97</c:f>
              <c:strCache>
                <c:ptCount val="15"/>
                <c:pt idx="0">
                  <c:v>Control</c:v>
                </c:pt>
                <c:pt idx="1">
                  <c:v>ACY-1215</c:v>
                </c:pt>
                <c:pt idx="2">
                  <c:v>Tubastatin A</c:v>
                </c:pt>
                <c:pt idx="3">
                  <c:v>DC661</c:v>
                </c:pt>
                <c:pt idx="4">
                  <c:v>Sclareol</c:v>
                </c:pt>
                <c:pt idx="5">
                  <c:v>Riluzole</c:v>
                </c:pt>
                <c:pt idx="6">
                  <c:v>Rapamycin</c:v>
                </c:pt>
                <c:pt idx="7">
                  <c:v>Dipyridamole</c:v>
                </c:pt>
                <c:pt idx="8">
                  <c:v>HCQ</c:v>
                </c:pt>
                <c:pt idx="9">
                  <c:v>DMNQ</c:v>
                </c:pt>
                <c:pt idx="10">
                  <c:v>Betulinic acid</c:v>
                </c:pt>
                <c:pt idx="11">
                  <c:v>Abiraterone</c:v>
                </c:pt>
                <c:pt idx="12">
                  <c:v>Rolipram</c:v>
                </c:pt>
                <c:pt idx="13">
                  <c:v>1,10-phen</c:v>
                </c:pt>
                <c:pt idx="14">
                  <c:v>Salinomycin</c:v>
                </c:pt>
              </c:strCache>
            </c:strRef>
          </c:cat>
          <c:val>
            <c:numRef>
              <c:f>EL.4!$L$83:$L$97</c:f>
              <c:numCache>
                <c:formatCode>General</c:formatCode>
                <c:ptCount val="15"/>
                <c:pt idx="0">
                  <c:v>100</c:v>
                </c:pt>
                <c:pt idx="1">
                  <c:v>130.596149</c:v>
                </c:pt>
                <c:pt idx="2">
                  <c:v>122.232406</c:v>
                </c:pt>
                <c:pt idx="3">
                  <c:v>120.15909600000001</c:v>
                </c:pt>
                <c:pt idx="4">
                  <c:v>113.063699</c:v>
                </c:pt>
                <c:pt idx="5">
                  <c:v>105.135623</c:v>
                </c:pt>
                <c:pt idx="6">
                  <c:v>104.50181499999999</c:v>
                </c:pt>
                <c:pt idx="7">
                  <c:v>101.464299</c:v>
                </c:pt>
                <c:pt idx="8">
                  <c:v>99.619277299999993</c:v>
                </c:pt>
                <c:pt idx="9">
                  <c:v>96.900489399999998</c:v>
                </c:pt>
                <c:pt idx="10">
                  <c:v>95.752243399999998</c:v>
                </c:pt>
                <c:pt idx="11">
                  <c:v>90.821568499999998</c:v>
                </c:pt>
                <c:pt idx="12">
                  <c:v>85.473460000000003</c:v>
                </c:pt>
                <c:pt idx="13">
                  <c:v>79.896820700000006</c:v>
                </c:pt>
                <c:pt idx="14">
                  <c:v>79.5586437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7BD-AF43-9CC7-2DD08CD0F0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575838335"/>
        <c:axId val="519223311"/>
      </c:barChart>
      <c:catAx>
        <c:axId val="5758383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19223311"/>
        <c:crosses val="autoZero"/>
        <c:auto val="1"/>
        <c:lblAlgn val="ctr"/>
        <c:lblOffset val="100"/>
        <c:noMultiLvlLbl val="0"/>
      </c:catAx>
      <c:valAx>
        <c:axId val="519223311"/>
        <c:scaling>
          <c:orientation val="minMax"/>
          <c:max val="16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600" b="1"/>
                  <a:t>Relative Proteasome Activity (%)</a:t>
                </a:r>
              </a:p>
            </c:rich>
          </c:tx>
          <c:layout>
            <c:manualLayout>
              <c:xMode val="edge"/>
              <c:yMode val="edge"/>
              <c:x val="2.4811604607188883E-2"/>
              <c:y val="0.126121423064652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5838335"/>
        <c:crosses val="autoZero"/>
        <c:crossBetween val="between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7314</cdr:x>
      <cdr:y>0</cdr:y>
    </cdr:from>
    <cdr:to>
      <cdr:x>0.32404</cdr:x>
      <cdr:y>0.05525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2218954" y="-498453"/>
          <a:ext cx="413498" cy="30565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>
              <a:latin typeface="Arial" panose="020B0604020202020204" pitchFamily="34" charset="0"/>
              <a:cs typeface="Arial" panose="020B0604020202020204" pitchFamily="34" charset="0"/>
            </a:rPr>
            <a:t>EG.7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n-US" dirty="0"/>
              <a:t>EG7 cell line highest </a:t>
            </a:r>
            <a:r>
              <a:rPr lang="en-US" dirty="0">
                <a:sym typeface="Wingdings" pitchFamily="2" charset="2"/>
              </a:rPr>
              <a:t> lowest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A50F36-1FE9-D14F-A131-9AA8B565D01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3060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9BBC739E-6BE1-6C44-BBFA-D4C748E4BFA2}"/>
              </a:ext>
            </a:extLst>
          </p:cNvPr>
          <p:cNvGraphicFramePr>
            <a:graphicFrameLocks/>
          </p:cNvGraphicFramePr>
          <p:nvPr/>
        </p:nvGraphicFramePr>
        <p:xfrm>
          <a:off x="0" y="498453"/>
          <a:ext cx="8123739" cy="55321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3140" y="16901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8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859462" y="2995329"/>
            <a:ext cx="6007330" cy="0"/>
          </a:xfrm>
          <a:prstGeom prst="line">
            <a:avLst/>
          </a:prstGeom>
          <a:ln w="1270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/>
          <p:cNvSpPr/>
          <p:nvPr/>
        </p:nvSpPr>
        <p:spPr>
          <a:xfrm>
            <a:off x="2054362" y="498633"/>
            <a:ext cx="164592" cy="164592"/>
          </a:xfrm>
          <a:prstGeom prst="rect">
            <a:avLst/>
          </a:prstGeom>
          <a:solidFill>
            <a:srgbClr val="00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054362" y="814587"/>
            <a:ext cx="164592" cy="16459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2218954" y="758383"/>
            <a:ext cx="5100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EL.4</a:t>
            </a:r>
          </a:p>
        </p:txBody>
      </p:sp>
      <p:sp>
        <p:nvSpPr>
          <p:cNvPr id="2" name="Rectangle 1"/>
          <p:cNvSpPr/>
          <p:nvPr/>
        </p:nvSpPr>
        <p:spPr>
          <a:xfrm>
            <a:off x="233857" y="5965587"/>
            <a:ext cx="765602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8.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Effect of top pharmacologics from the HTS that inhibited proteasome ChT-like activity </a:t>
            </a:r>
            <a:r>
              <a:rPr lang="en-US" sz="120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in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E.G7-Ova and </a:t>
            </a:r>
            <a:r>
              <a:rPr lang="en-US" sz="120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L4 </a:t>
            </a:r>
            <a:r>
              <a:rPr lang="en-US" sz="1200">
                <a:latin typeface="Times New Roman" panose="02020603050405020304" pitchFamily="18" charset="0"/>
                <a:ea typeface="Times New Roman" panose="02020603050405020304" pitchFamily="18" charset="0"/>
              </a:rPr>
              <a:t>cells. Cells (50,000/well) were incubated with each pharmacologic for 72 hrs. Proteasome ChT-like activity was determined after 24 hrs incubation. E.G7-Ova and EL4 cells. Cells (50,000/well) were incubated with each pharmacologic for 72 h. Proteasome ChT-like activity was determined after 24 h incubation.</a:t>
            </a:r>
          </a:p>
        </p:txBody>
      </p:sp>
    </p:spTree>
    <p:extLst>
      <p:ext uri="{BB962C8B-B14F-4D97-AF65-F5344CB8AC3E}">
        <p14:creationId xmlns:p14="http://schemas.microsoft.com/office/powerpoint/2010/main" val="2326795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5</TotalTime>
  <Words>89</Words>
  <Application>Microsoft Office PowerPoint</Application>
  <PresentationFormat>Widescreen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2</cp:revision>
  <cp:lastPrinted>2024-03-02T18:31:01Z</cp:lastPrinted>
  <dcterms:created xsi:type="dcterms:W3CDTF">2022-08-15T18:48:13Z</dcterms:created>
  <dcterms:modified xsi:type="dcterms:W3CDTF">2024-05-08T21:44:31Z</dcterms:modified>
</cp:coreProperties>
</file>